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3.jpeg" ContentType="image/jpe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79433E-E7EE-47CB-89BB-1D70CA0C36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04B430F-D4DB-4995-8873-1581B5A3E23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64B863-8B50-48DA-A282-12E11A55F0F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54BC66-E76D-4790-A504-5D0F363CFA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919658-1890-4C18-9A64-C8B304FC950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517949-7CBC-4EFF-93C8-CFEE52B4B06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ABDA8D-D348-4A65-A696-34516A1AA79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EED9B8-6EB6-47A6-80EB-0529E4DF087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B639BA-E56B-4276-93E3-9CB50E1666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8084B6-555D-45C6-BF96-1E1BF81651C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B37A92-3875-41AC-83A6-10BC1B9E3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7249AA-8DEB-4A95-B765-1D47BBFDF6E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3A39DA2-5763-438F-98E2-015605EF7D1B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jpeg"/><Relationship Id="rId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3"/>
          <p:cNvSpPr/>
          <p:nvPr/>
        </p:nvSpPr>
        <p:spPr>
          <a:xfrm>
            <a:off x="262440" y="279360"/>
            <a:ext cx="4704120" cy="1006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Each slides holds 48 of 11x11 grid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Each slide accommodates 5808 spots for 1056 samples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Each slides accommodates additional 528 replicated control spots for Q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Each sample processed for five 2-fold-serial dilutions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Each slide probed for one antibody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2160" y="1452600"/>
            <a:ext cx="8913240" cy="2809800"/>
            <a:chOff x="2160" y="1452600"/>
            <a:chExt cx="8913240" cy="2809800"/>
          </a:xfrm>
        </p:grpSpPr>
        <p:pic>
          <p:nvPicPr>
            <p:cNvPr id="43" name="Picture 5" descr="AKT_pS473(V)_GBL0000510.tif"/>
            <p:cNvPicPr/>
            <p:nvPr/>
          </p:nvPicPr>
          <p:blipFill>
            <a:blip r:embed="rId1"/>
            <a:stretch/>
          </p:blipFill>
          <p:spPr>
            <a:xfrm>
              <a:off x="228960" y="1571400"/>
              <a:ext cx="8686440" cy="26910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4" name="TextBox 6"/>
            <p:cNvSpPr/>
            <p:nvPr/>
          </p:nvSpPr>
          <p:spPr>
            <a:xfrm>
              <a:off x="10440" y="1846800"/>
              <a:ext cx="304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A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TextBox 7"/>
            <p:cNvSpPr/>
            <p:nvPr/>
          </p:nvSpPr>
          <p:spPr>
            <a:xfrm>
              <a:off x="2160" y="2445120"/>
              <a:ext cx="29520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B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TextBox 8"/>
            <p:cNvSpPr/>
            <p:nvPr/>
          </p:nvSpPr>
          <p:spPr>
            <a:xfrm>
              <a:off x="2880" y="3001320"/>
              <a:ext cx="2872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C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TextBox 9"/>
            <p:cNvSpPr/>
            <p:nvPr/>
          </p:nvSpPr>
          <p:spPr>
            <a:xfrm>
              <a:off x="2520" y="3560040"/>
              <a:ext cx="30888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16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D</a:t>
              </a:r>
              <a:endParaRPr b="0" lang="en-US" sz="16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10"/>
            <p:cNvSpPr/>
            <p:nvPr/>
          </p:nvSpPr>
          <p:spPr>
            <a:xfrm>
              <a:off x="512640" y="1771560"/>
              <a:ext cx="563400" cy="579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prstDash val="sysDash"/>
              <a:round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11"/>
            <p:cNvSpPr/>
            <p:nvPr/>
          </p:nvSpPr>
          <p:spPr>
            <a:xfrm>
              <a:off x="514080" y="2370240"/>
              <a:ext cx="563400" cy="5443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prstDash val="sysDash"/>
              <a:round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12"/>
            <p:cNvSpPr/>
            <p:nvPr/>
          </p:nvSpPr>
          <p:spPr>
            <a:xfrm>
              <a:off x="506160" y="2932200"/>
              <a:ext cx="563400" cy="53172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prstDash val="sysDash"/>
              <a:round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13"/>
            <p:cNvSpPr/>
            <p:nvPr/>
          </p:nvSpPr>
          <p:spPr>
            <a:xfrm>
              <a:off x="500040" y="3473640"/>
              <a:ext cx="561960" cy="55224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prstDash val="sysDash"/>
              <a:round/>
            </a:ln>
            <a:effectLst>
              <a:outerShdw dist="23040" dir="5400000" blurRad="0" rotWithShape="0">
                <a:srgbClr val="000000">
                  <a:alpha val="35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TextBox 14"/>
            <p:cNvSpPr/>
            <p:nvPr/>
          </p:nvSpPr>
          <p:spPr>
            <a:xfrm>
              <a:off x="66636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15"/>
            <p:cNvSpPr/>
            <p:nvPr/>
          </p:nvSpPr>
          <p:spPr>
            <a:xfrm>
              <a:off x="123084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16"/>
            <p:cNvSpPr/>
            <p:nvPr/>
          </p:nvSpPr>
          <p:spPr>
            <a:xfrm>
              <a:off x="177048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3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TextBox 17"/>
            <p:cNvSpPr/>
            <p:nvPr/>
          </p:nvSpPr>
          <p:spPr>
            <a:xfrm>
              <a:off x="231804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TextBox 18"/>
            <p:cNvSpPr/>
            <p:nvPr/>
          </p:nvSpPr>
          <p:spPr>
            <a:xfrm>
              <a:off x="289116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5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TextBox 19"/>
            <p:cNvSpPr/>
            <p:nvPr/>
          </p:nvSpPr>
          <p:spPr>
            <a:xfrm>
              <a:off x="343872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6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TextBox 20"/>
            <p:cNvSpPr/>
            <p:nvPr/>
          </p:nvSpPr>
          <p:spPr>
            <a:xfrm>
              <a:off x="399492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7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21"/>
            <p:cNvSpPr/>
            <p:nvPr/>
          </p:nvSpPr>
          <p:spPr>
            <a:xfrm>
              <a:off x="455112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8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TextBox 22"/>
            <p:cNvSpPr/>
            <p:nvPr/>
          </p:nvSpPr>
          <p:spPr>
            <a:xfrm>
              <a:off x="5107320" y="1452600"/>
              <a:ext cx="27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9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TextBox 23"/>
            <p:cNvSpPr/>
            <p:nvPr/>
          </p:nvSpPr>
          <p:spPr>
            <a:xfrm>
              <a:off x="5630400" y="1452600"/>
              <a:ext cx="36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0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TextBox 24"/>
            <p:cNvSpPr/>
            <p:nvPr/>
          </p:nvSpPr>
          <p:spPr>
            <a:xfrm>
              <a:off x="6177960" y="1452600"/>
              <a:ext cx="36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TextBox 25"/>
            <p:cNvSpPr/>
            <p:nvPr/>
          </p:nvSpPr>
          <p:spPr>
            <a:xfrm>
              <a:off x="6742800" y="1452600"/>
              <a:ext cx="3607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2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4" name="TextBox 26"/>
          <p:cNvSpPr/>
          <p:nvPr/>
        </p:nvSpPr>
        <p:spPr>
          <a:xfrm>
            <a:off x="731160" y="5710320"/>
            <a:ext cx="208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22 samples in each 11x11 grad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65" name="Group 27"/>
          <p:cNvGrpSpPr/>
          <p:nvPr/>
        </p:nvGrpSpPr>
        <p:grpSpPr>
          <a:xfrm>
            <a:off x="2917800" y="4844880"/>
            <a:ext cx="2506680" cy="2013120"/>
            <a:chOff x="2917800" y="4844880"/>
            <a:chExt cx="2506680" cy="2013120"/>
          </a:xfrm>
        </p:grpSpPr>
        <p:pic>
          <p:nvPicPr>
            <p:cNvPr id="66" name="Picture 28" descr="AKT_pS473(V)_GBL0000510.tif"/>
            <p:cNvPicPr/>
            <p:nvPr/>
          </p:nvPicPr>
          <p:blipFill>
            <a:blip r:embed="rId2"/>
            <a:srcRect l="3272" t="7989" r="90269" b="70891"/>
            <a:stretch/>
          </p:blipFill>
          <p:spPr>
            <a:xfrm>
              <a:off x="3481200" y="4878360"/>
              <a:ext cx="1943280" cy="19688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7" name="TextBox 29"/>
            <p:cNvSpPr/>
            <p:nvPr/>
          </p:nvSpPr>
          <p:spPr>
            <a:xfrm>
              <a:off x="3001680" y="4844880"/>
              <a:ext cx="6282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 &amp; 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TextBox 30"/>
            <p:cNvSpPr/>
            <p:nvPr/>
          </p:nvSpPr>
          <p:spPr>
            <a:xfrm>
              <a:off x="3001680" y="5022360"/>
              <a:ext cx="6645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3 &amp; 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31"/>
            <p:cNvSpPr/>
            <p:nvPr/>
          </p:nvSpPr>
          <p:spPr>
            <a:xfrm>
              <a:off x="3001680" y="5191560"/>
              <a:ext cx="737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5 &amp; 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TextBox 32"/>
            <p:cNvSpPr/>
            <p:nvPr/>
          </p:nvSpPr>
          <p:spPr>
            <a:xfrm>
              <a:off x="2993400" y="5377680"/>
              <a:ext cx="7293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7 &amp; 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TextBox 33"/>
            <p:cNvSpPr/>
            <p:nvPr/>
          </p:nvSpPr>
          <p:spPr>
            <a:xfrm>
              <a:off x="2993400" y="5538600"/>
              <a:ext cx="8218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9 &amp; 1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34"/>
            <p:cNvSpPr/>
            <p:nvPr/>
          </p:nvSpPr>
          <p:spPr>
            <a:xfrm>
              <a:off x="2926080" y="5724720"/>
              <a:ext cx="8722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1 &amp; 1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TextBox 35"/>
            <p:cNvSpPr/>
            <p:nvPr/>
          </p:nvSpPr>
          <p:spPr>
            <a:xfrm>
              <a:off x="2926080" y="5910840"/>
              <a:ext cx="811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3 &amp; 14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TextBox 36"/>
            <p:cNvSpPr/>
            <p:nvPr/>
          </p:nvSpPr>
          <p:spPr>
            <a:xfrm>
              <a:off x="2917800" y="6071760"/>
              <a:ext cx="7840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5 &amp; 16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37"/>
            <p:cNvSpPr/>
            <p:nvPr/>
          </p:nvSpPr>
          <p:spPr>
            <a:xfrm>
              <a:off x="2917800" y="6240960"/>
              <a:ext cx="6811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7 &amp; 1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TextBox 38"/>
            <p:cNvSpPr/>
            <p:nvPr/>
          </p:nvSpPr>
          <p:spPr>
            <a:xfrm>
              <a:off x="2917800" y="6418800"/>
              <a:ext cx="7041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9 &amp; 18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TextBox 39"/>
            <p:cNvSpPr/>
            <p:nvPr/>
          </p:nvSpPr>
          <p:spPr>
            <a:xfrm>
              <a:off x="2917800" y="6596640"/>
              <a:ext cx="6937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21 &amp; 2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78" name="Left Brace 40"/>
          <p:cNvSpPr/>
          <p:nvPr/>
        </p:nvSpPr>
        <p:spPr>
          <a:xfrm>
            <a:off x="2784600" y="4987800"/>
            <a:ext cx="160200" cy="1757520"/>
          </a:xfrm>
          <a:custGeom>
            <a:avLst/>
            <a:gdLst>
              <a:gd name="textAreaLeft" fmla="*/ 102240 w 160200"/>
              <a:gd name="textAreaRight" fmla="*/ 160560 w 160200"/>
              <a:gd name="textAreaTop" fmla="*/ 3960 h 1757520"/>
              <a:gd name="textAreaBottom" fmla="*/ 1753560 h 175752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2"/>
                  <a:pt x="10800" y="164"/>
                </a:cubicBezTo>
                <a:lnTo>
                  <a:pt x="10800" y="10636"/>
                </a:lnTo>
                <a:cubicBezTo>
                  <a:pt x="10800" y="10718"/>
                  <a:pt x="5400" y="10800"/>
                  <a:pt x="0" y="10800"/>
                </a:cubicBezTo>
                <a:cubicBezTo>
                  <a:pt x="5400" y="10800"/>
                  <a:pt x="10800" y="10882"/>
                  <a:pt x="10800" y="10964"/>
                </a:cubicBezTo>
                <a:lnTo>
                  <a:pt x="10800" y="21436"/>
                </a:lnTo>
                <a:cubicBezTo>
                  <a:pt x="10800" y="21518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79" name="Group 41"/>
          <p:cNvGrpSpPr/>
          <p:nvPr/>
        </p:nvGrpSpPr>
        <p:grpSpPr>
          <a:xfrm>
            <a:off x="3440160" y="4233600"/>
            <a:ext cx="988200" cy="730440"/>
            <a:chOff x="3440160" y="4233600"/>
            <a:chExt cx="988200" cy="730440"/>
          </a:xfrm>
        </p:grpSpPr>
        <p:sp>
          <p:nvSpPr>
            <p:cNvPr id="80" name="TextBox 42"/>
            <p:cNvSpPr/>
            <p:nvPr/>
          </p:nvSpPr>
          <p:spPr>
            <a:xfrm rot="16200000">
              <a:off x="3652920" y="454284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: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1" name="Group 47"/>
            <p:cNvGrpSpPr/>
            <p:nvPr/>
          </p:nvGrpSpPr>
          <p:grpSpPr>
            <a:xfrm>
              <a:off x="3440160" y="4233600"/>
              <a:ext cx="988200" cy="730440"/>
              <a:chOff x="3440160" y="4233600"/>
              <a:chExt cx="988200" cy="730440"/>
            </a:xfrm>
          </p:grpSpPr>
          <p:sp>
            <p:nvSpPr>
              <p:cNvPr id="82" name="TextBox 41"/>
              <p:cNvSpPr/>
              <p:nvPr/>
            </p:nvSpPr>
            <p:spPr>
              <a:xfrm rot="16200000">
                <a:off x="3447000" y="4624200"/>
                <a:ext cx="26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宋体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83" name="Group 46"/>
              <p:cNvGrpSpPr/>
              <p:nvPr/>
            </p:nvGrpSpPr>
            <p:grpSpPr>
              <a:xfrm>
                <a:off x="3620160" y="4233600"/>
                <a:ext cx="808200" cy="730440"/>
                <a:chOff x="3620160" y="4233600"/>
                <a:chExt cx="808200" cy="730440"/>
              </a:xfrm>
            </p:grpSpPr>
            <p:sp>
              <p:nvSpPr>
                <p:cNvPr id="84" name="TextBox 46"/>
                <p:cNvSpPr/>
                <p:nvPr/>
              </p:nvSpPr>
              <p:spPr>
                <a:xfrm rot="16200000">
                  <a:off x="3475800" y="4538880"/>
                  <a:ext cx="565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2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5" name="TextBox 44"/>
                <p:cNvSpPr/>
                <p:nvPr/>
              </p:nvSpPr>
              <p:spPr>
                <a:xfrm rot="16200000">
                  <a:off x="3822120" y="4543200"/>
                  <a:ext cx="565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8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6" name="TextBox 48"/>
                <p:cNvSpPr/>
                <p:nvPr/>
              </p:nvSpPr>
              <p:spPr>
                <a:xfrm rot="16200000">
                  <a:off x="3926880" y="4458240"/>
                  <a:ext cx="726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16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87" name="Group 49"/>
          <p:cNvGrpSpPr/>
          <p:nvPr/>
        </p:nvGrpSpPr>
        <p:grpSpPr>
          <a:xfrm>
            <a:off x="4317840" y="4228920"/>
            <a:ext cx="988560" cy="730440"/>
            <a:chOff x="4317840" y="4228920"/>
            <a:chExt cx="988560" cy="730440"/>
          </a:xfrm>
        </p:grpSpPr>
        <p:sp>
          <p:nvSpPr>
            <p:cNvPr id="88" name="TextBox 50"/>
            <p:cNvSpPr/>
            <p:nvPr/>
          </p:nvSpPr>
          <p:spPr>
            <a:xfrm rot="16200000">
              <a:off x="4530960" y="453816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1:4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89" name="Group 51"/>
            <p:cNvGrpSpPr/>
            <p:nvPr/>
          </p:nvGrpSpPr>
          <p:grpSpPr>
            <a:xfrm>
              <a:off x="4317840" y="4228920"/>
              <a:ext cx="988560" cy="730440"/>
              <a:chOff x="4317840" y="4228920"/>
              <a:chExt cx="988560" cy="730440"/>
            </a:xfrm>
          </p:grpSpPr>
          <p:sp>
            <p:nvSpPr>
              <p:cNvPr id="90" name="TextBox 52"/>
              <p:cNvSpPr/>
              <p:nvPr/>
            </p:nvSpPr>
            <p:spPr>
              <a:xfrm rot="16200000">
                <a:off x="4324680" y="4619520"/>
                <a:ext cx="2628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Calibri"/>
                    <a:ea typeface="宋体"/>
                  </a:rPr>
                  <a:t>0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91" name="Group 53"/>
              <p:cNvGrpSpPr/>
              <p:nvPr/>
            </p:nvGrpSpPr>
            <p:grpSpPr>
              <a:xfrm>
                <a:off x="4497840" y="4228920"/>
                <a:ext cx="808560" cy="730440"/>
                <a:chOff x="4497840" y="4228920"/>
                <a:chExt cx="808560" cy="730440"/>
              </a:xfrm>
            </p:grpSpPr>
            <p:sp>
              <p:nvSpPr>
                <p:cNvPr id="92" name="TextBox 54"/>
                <p:cNvSpPr/>
                <p:nvPr/>
              </p:nvSpPr>
              <p:spPr>
                <a:xfrm rot="16200000">
                  <a:off x="4353480" y="4534200"/>
                  <a:ext cx="565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2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3" name="TextBox 55"/>
                <p:cNvSpPr/>
                <p:nvPr/>
              </p:nvSpPr>
              <p:spPr>
                <a:xfrm rot="16200000">
                  <a:off x="4699800" y="4538520"/>
                  <a:ext cx="5652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8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94" name="TextBox 56"/>
                <p:cNvSpPr/>
                <p:nvPr/>
              </p:nvSpPr>
              <p:spPr>
                <a:xfrm rot="16200000">
                  <a:off x="4804920" y="4453560"/>
                  <a:ext cx="72612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457200"/>
                      <a:tab algn="l" pos="914400"/>
                      <a:tab algn="l" pos="1371600"/>
                      <a:tab algn="l" pos="1828800"/>
                      <a:tab algn="l" pos="2286000"/>
                      <a:tab algn="l" pos="2743200"/>
                      <a:tab algn="l" pos="3200400"/>
                      <a:tab algn="l" pos="3657600"/>
                      <a:tab algn="l" pos="4114800"/>
                      <a:tab algn="l" pos="4572000"/>
                      <a:tab algn="l" pos="5029200"/>
                      <a:tab algn="l" pos="5486400"/>
                      <a:tab algn="l" pos="5943600"/>
                      <a:tab algn="l" pos="6400800"/>
                      <a:tab algn="l" pos="6858000"/>
                      <a:tab algn="l" pos="7315200"/>
                      <a:tab algn="l" pos="7772400"/>
                      <a:tab algn="l" pos="8229600"/>
                      <a:tab algn="l" pos="8686800"/>
                      <a:tab algn="l" pos="9144000"/>
                    </a:tabLst>
                  </a:pPr>
                  <a:r>
                    <a:rPr b="0" lang="en-US" sz="1200" spc="-1" strike="noStrike">
                      <a:solidFill>
                        <a:srgbClr val="000000"/>
                      </a:solidFill>
                      <a:latin typeface="Calibri"/>
                      <a:ea typeface="宋体"/>
                    </a:rPr>
                    <a:t>1:16</a:t>
                  </a:r>
                  <a:endParaRPr b="0" lang="en-US" sz="12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sp>
        <p:nvSpPr>
          <p:cNvPr id="95" name="TextBox 57"/>
          <p:cNvSpPr/>
          <p:nvPr/>
        </p:nvSpPr>
        <p:spPr>
          <a:xfrm>
            <a:off x="3220920" y="4213080"/>
            <a:ext cx="24577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2-fold serial dilution for each sampl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6" name="Left Brace 58"/>
          <p:cNvSpPr/>
          <p:nvPr/>
        </p:nvSpPr>
        <p:spPr>
          <a:xfrm rot="5400000">
            <a:off x="4306680" y="3647880"/>
            <a:ext cx="158760" cy="1758960"/>
          </a:xfrm>
          <a:custGeom>
            <a:avLst/>
            <a:gdLst>
              <a:gd name="textAreaLeft" fmla="*/ 101520 w 158760"/>
              <a:gd name="textAreaRight" fmla="*/ 159120 w 158760"/>
              <a:gd name="textAreaTop" fmla="*/ 3960 h 1758960"/>
              <a:gd name="textAreaBottom" fmla="*/ 1755000 h 1758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81"/>
                  <a:pt x="10800" y="162"/>
                </a:cubicBezTo>
                <a:lnTo>
                  <a:pt x="10800" y="10638"/>
                </a:lnTo>
                <a:cubicBezTo>
                  <a:pt x="10800" y="10719"/>
                  <a:pt x="5400" y="10800"/>
                  <a:pt x="0" y="10800"/>
                </a:cubicBezTo>
                <a:cubicBezTo>
                  <a:pt x="5400" y="10800"/>
                  <a:pt x="10800" y="10881"/>
                  <a:pt x="10800" y="10962"/>
                </a:cubicBezTo>
                <a:lnTo>
                  <a:pt x="10800" y="21438"/>
                </a:lnTo>
                <a:cubicBezTo>
                  <a:pt x="10800" y="21519"/>
                  <a:pt x="16200" y="21600"/>
                  <a:pt x="21600" y="21600"/>
                </a:cubicBezTo>
              </a:path>
            </a:pathLst>
          </a:custGeom>
          <a:noFill/>
          <a:ln w="12600">
            <a:solidFill>
              <a:srgbClr val="000000"/>
            </a:solidFill>
            <a:miter/>
          </a:ln>
          <a:effectLst>
            <a:outerShdw dist="20160" dir="5400000" blurRad="0" rotWithShape="0">
              <a:srgbClr val="000000">
                <a:alpha val="38000"/>
              </a:srgbClr>
            </a:outerShdw>
          </a:effectLst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97" name="Group 59"/>
          <p:cNvGrpSpPr/>
          <p:nvPr/>
        </p:nvGrpSpPr>
        <p:grpSpPr>
          <a:xfrm>
            <a:off x="5335560" y="4687920"/>
            <a:ext cx="1666800" cy="861840"/>
            <a:chOff x="5335560" y="4687920"/>
            <a:chExt cx="1666800" cy="861840"/>
          </a:xfrm>
        </p:grpSpPr>
        <p:sp>
          <p:nvSpPr>
            <p:cNvPr id="98" name="Straight Connector 60"/>
            <p:cNvSpPr/>
            <p:nvPr/>
          </p:nvSpPr>
          <p:spPr>
            <a:xfrm flipH="1">
              <a:off x="5343480" y="4689360"/>
              <a:ext cx="1440" cy="168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  <a:tailEnd len="med" type="triangle" w="med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Straight Connector 61"/>
            <p:cNvSpPr/>
            <p:nvPr/>
          </p:nvSpPr>
          <p:spPr>
            <a:xfrm>
              <a:off x="5335560" y="4687920"/>
              <a:ext cx="166680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Straight Connector 62"/>
            <p:cNvSpPr/>
            <p:nvPr/>
          </p:nvSpPr>
          <p:spPr>
            <a:xfrm flipH="1">
              <a:off x="6996240" y="4692600"/>
              <a:ext cx="1440" cy="8571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1" name="TextBox 63"/>
          <p:cNvSpPr/>
          <p:nvPr/>
        </p:nvSpPr>
        <p:spPr>
          <a:xfrm>
            <a:off x="6616800" y="5522760"/>
            <a:ext cx="185544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Last colum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Control lysate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(in serial dilution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Spotted in each grid for QC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grpSp>
        <p:nvGrpSpPr>
          <p:cNvPr id="102" name="Group 64"/>
          <p:cNvGrpSpPr/>
          <p:nvPr/>
        </p:nvGrpSpPr>
        <p:grpSpPr>
          <a:xfrm>
            <a:off x="5729400" y="4854600"/>
            <a:ext cx="876240" cy="2003040"/>
            <a:chOff x="5729400" y="4854600"/>
            <a:chExt cx="876240" cy="2003040"/>
          </a:xfrm>
        </p:grpSpPr>
        <p:sp>
          <p:nvSpPr>
            <p:cNvPr id="103" name="TextBox 65"/>
            <p:cNvSpPr/>
            <p:nvPr/>
          </p:nvSpPr>
          <p:spPr>
            <a:xfrm>
              <a:off x="5742000" y="521136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4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TextBox 66"/>
            <p:cNvSpPr/>
            <p:nvPr/>
          </p:nvSpPr>
          <p:spPr>
            <a:xfrm>
              <a:off x="5754240" y="4854600"/>
              <a:ext cx="85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0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TextBox 67"/>
            <p:cNvSpPr/>
            <p:nvPr/>
          </p:nvSpPr>
          <p:spPr>
            <a:xfrm>
              <a:off x="5745960" y="503424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2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TextBox 68"/>
            <p:cNvSpPr/>
            <p:nvPr/>
          </p:nvSpPr>
          <p:spPr>
            <a:xfrm>
              <a:off x="5741640" y="538020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TextBox 69"/>
            <p:cNvSpPr/>
            <p:nvPr/>
          </p:nvSpPr>
          <p:spPr>
            <a:xfrm>
              <a:off x="5745960" y="5565600"/>
              <a:ext cx="72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16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TextBox 70"/>
            <p:cNvSpPr/>
            <p:nvPr/>
          </p:nvSpPr>
          <p:spPr>
            <a:xfrm>
              <a:off x="5733720" y="6581160"/>
              <a:ext cx="8514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0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TextBox 71"/>
            <p:cNvSpPr/>
            <p:nvPr/>
          </p:nvSpPr>
          <p:spPr>
            <a:xfrm>
              <a:off x="5733720" y="640692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2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TextBox 72"/>
            <p:cNvSpPr/>
            <p:nvPr/>
          </p:nvSpPr>
          <p:spPr>
            <a:xfrm>
              <a:off x="5733360" y="5718240"/>
              <a:ext cx="72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Buffer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TextBox 73"/>
            <p:cNvSpPr/>
            <p:nvPr/>
          </p:nvSpPr>
          <p:spPr>
            <a:xfrm>
              <a:off x="5729400" y="5892120"/>
              <a:ext cx="7257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16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TextBox 74"/>
            <p:cNvSpPr/>
            <p:nvPr/>
          </p:nvSpPr>
          <p:spPr>
            <a:xfrm>
              <a:off x="5729400" y="605232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8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TextBox 75"/>
            <p:cNvSpPr/>
            <p:nvPr/>
          </p:nvSpPr>
          <p:spPr>
            <a:xfrm>
              <a:off x="5729760" y="6221520"/>
              <a:ext cx="5652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Calibri"/>
                  <a:ea typeface="宋体"/>
                </a:rPr>
                <a:t>(1:4)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Left Brace 76"/>
            <p:cNvSpPr/>
            <p:nvPr/>
          </p:nvSpPr>
          <p:spPr>
            <a:xfrm flipH="1">
              <a:off x="6333480" y="4983120"/>
              <a:ext cx="160200" cy="1757520"/>
            </a:xfrm>
            <a:custGeom>
              <a:avLst/>
              <a:gdLst>
                <a:gd name="textAreaLeft" fmla="*/ 101880 w 160200"/>
                <a:gd name="textAreaRight" fmla="*/ 160200 w 160200"/>
                <a:gd name="textAreaTop" fmla="*/ 3960 h 1757520"/>
                <a:gd name="textAreaBottom" fmla="*/ 1753560 h 175752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6200" y="0"/>
                    <a:pt x="10800" y="82"/>
                    <a:pt x="10800" y="164"/>
                  </a:cubicBezTo>
                  <a:lnTo>
                    <a:pt x="10800" y="10636"/>
                  </a:lnTo>
                  <a:cubicBezTo>
                    <a:pt x="10800" y="10718"/>
                    <a:pt x="5400" y="10800"/>
                    <a:pt x="0" y="10800"/>
                  </a:cubicBezTo>
                  <a:cubicBezTo>
                    <a:pt x="5400" y="10800"/>
                    <a:pt x="10800" y="10882"/>
                    <a:pt x="10800" y="10964"/>
                  </a:cubicBezTo>
                  <a:lnTo>
                    <a:pt x="10800" y="21436"/>
                  </a:lnTo>
                  <a:cubicBezTo>
                    <a:pt x="10800" y="21518"/>
                    <a:pt x="16200" y="21600"/>
                    <a:pt x="21600" y="21600"/>
                  </a:cubicBezTo>
                </a:path>
              </a:pathLst>
            </a:custGeom>
            <a:noFill/>
            <a:ln w="12600">
              <a:solidFill>
                <a:srgbClr val="000000"/>
              </a:solidFill>
              <a:miter/>
            </a:ln>
            <a:effectLst>
              <a:outerShdw dist="20160" dir="5400000" blurRad="0" rotWithShape="0">
                <a:srgbClr val="000000">
                  <a:alpha val="38000"/>
                </a:srgbClr>
              </a:outerShdw>
            </a:effectLst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15" name="TextBox 77"/>
          <p:cNvSpPr/>
          <p:nvPr/>
        </p:nvSpPr>
        <p:spPr>
          <a:xfrm>
            <a:off x="5583240" y="4675320"/>
            <a:ext cx="1278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(Control Lysate)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6" name="TextBox 78"/>
          <p:cNvSpPr/>
          <p:nvPr/>
        </p:nvSpPr>
        <p:spPr>
          <a:xfrm>
            <a:off x="5675760" y="4429080"/>
            <a:ext cx="92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  <a:ea typeface="宋体"/>
              </a:rPr>
              <a:t>Last colum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117" name="Picture 79" descr="DSCN1016-1.jpg"/>
          <p:cNvPicPr/>
          <p:nvPr/>
        </p:nvPicPr>
        <p:blipFill>
          <a:blip r:embed="rId3"/>
          <a:srcRect l="0" t="0" r="0" b="1986"/>
          <a:stretch/>
        </p:blipFill>
        <p:spPr>
          <a:xfrm>
            <a:off x="6424560" y="41400"/>
            <a:ext cx="2621160" cy="1476360"/>
          </a:xfrm>
          <a:prstGeom prst="rect">
            <a:avLst/>
          </a:prstGeom>
          <a:ln w="0">
            <a:noFill/>
          </a:ln>
        </p:spPr>
      </p:pic>
      <p:sp>
        <p:nvSpPr>
          <p:cNvPr id="118" name="TextBox 78"/>
          <p:cNvSpPr/>
          <p:nvPr/>
        </p:nvSpPr>
        <p:spPr>
          <a:xfrm>
            <a:off x="3322440" y="0"/>
            <a:ext cx="14655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Calibri"/>
                <a:ea typeface="宋体"/>
              </a:rPr>
              <a:t>Slide Layout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9" name="Text Box 6"/>
          <p:cNvSpPr/>
          <p:nvPr/>
        </p:nvSpPr>
        <p:spPr>
          <a:xfrm>
            <a:off x="478080" y="6248520"/>
            <a:ext cx="1555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. Figure 1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2-16T23:19:50Z</dcterms:created>
  <dc:creator>HGuo</dc:creator>
  <dc:description/>
  <dc:language>en-US</dc:language>
  <cp:lastModifiedBy>HGuo</cp:lastModifiedBy>
  <dcterms:modified xsi:type="dcterms:W3CDTF">2012-02-16T23:28:02Z</dcterms:modified>
  <cp:revision>1</cp:revision>
  <dc:subject/>
  <dc:title>Slide 1</dc:title>
</cp:coreProperties>
</file>